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  <p:sldId id="284" r:id="rId3"/>
    <p:sldId id="285" r:id="rId4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27E00"/>
    <a:srgbClr val="55752F"/>
    <a:srgbClr val="90353B"/>
    <a:srgbClr val="1A476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35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91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21F84-80BF-4EAC-B1D3-5080525A6BDF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23D695-F1D8-45F3-A58B-2A19EDC56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8210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21F84-80BF-4EAC-B1D3-5080525A6BDF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23D695-F1D8-45F3-A58B-2A19EDC56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8938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21F84-80BF-4EAC-B1D3-5080525A6BDF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23D695-F1D8-45F3-A58B-2A19EDC56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18134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21F84-80BF-4EAC-B1D3-5080525A6BDF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23D695-F1D8-45F3-A58B-2A19EDC56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9080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21F84-80BF-4EAC-B1D3-5080525A6BDF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23D695-F1D8-45F3-A58B-2A19EDC56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8031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21F84-80BF-4EAC-B1D3-5080525A6BDF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23D695-F1D8-45F3-A58B-2A19EDC56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60925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21F84-80BF-4EAC-B1D3-5080525A6BDF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23D695-F1D8-45F3-A58B-2A19EDC56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319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21F84-80BF-4EAC-B1D3-5080525A6BDF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23D695-F1D8-45F3-A58B-2A19EDC56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00346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21F84-80BF-4EAC-B1D3-5080525A6BDF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23D695-F1D8-45F3-A58B-2A19EDC56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5046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21F84-80BF-4EAC-B1D3-5080525A6BDF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23D695-F1D8-45F3-A58B-2A19EDC56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0394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21F84-80BF-4EAC-B1D3-5080525A6BDF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23D695-F1D8-45F3-A58B-2A19EDC56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1956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021F84-80BF-4EAC-B1D3-5080525A6BDF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23D695-F1D8-45F3-A58B-2A19EDC56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360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4" name="Straight Connector 43"/>
          <p:cNvCxnSpPr/>
          <p:nvPr/>
        </p:nvCxnSpPr>
        <p:spPr>
          <a:xfrm flipH="1">
            <a:off x="3556607" y="1393656"/>
            <a:ext cx="959684" cy="68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4516700" y="886744"/>
            <a:ext cx="0" cy="86832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 flipH="1">
            <a:off x="1766125" y="1746863"/>
            <a:ext cx="1141" cy="160478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flipH="1">
            <a:off x="2712936" y="1746864"/>
            <a:ext cx="2668" cy="15631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 flipH="1">
            <a:off x="3665648" y="1746865"/>
            <a:ext cx="2668" cy="15631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 flipH="1">
            <a:off x="4585013" y="1746865"/>
            <a:ext cx="2668" cy="15631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 flipH="1">
            <a:off x="5522864" y="1746865"/>
            <a:ext cx="2668" cy="15631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 flipH="1">
            <a:off x="8344930" y="1744881"/>
            <a:ext cx="2668" cy="15631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3"/>
          <p:cNvSpPr/>
          <p:nvPr/>
        </p:nvSpPr>
        <p:spPr>
          <a:xfrm>
            <a:off x="3918839" y="759695"/>
            <a:ext cx="1191899" cy="36221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1,939 total patients with clinical HTN diagnosis</a:t>
            </a:r>
          </a:p>
        </p:txBody>
      </p:sp>
      <p:cxnSp>
        <p:nvCxnSpPr>
          <p:cNvPr id="10" name="Straight Connector 9"/>
          <p:cNvCxnSpPr/>
          <p:nvPr/>
        </p:nvCxnSpPr>
        <p:spPr>
          <a:xfrm flipV="1">
            <a:off x="825295" y="1748628"/>
            <a:ext cx="7517984" cy="335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4257534" y="461694"/>
            <a:ext cx="562975" cy="3779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ite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65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7894768" y="1888194"/>
            <a:ext cx="910829" cy="36213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,255 not prescribed antihypertensive drug (Untreated)</a:t>
            </a:r>
          </a:p>
        </p:txBody>
      </p:sp>
      <p:sp>
        <p:nvSpPr>
          <p:cNvPr id="30" name="Rectangle 29"/>
          <p:cNvSpPr/>
          <p:nvPr/>
        </p:nvSpPr>
        <p:spPr>
          <a:xfrm>
            <a:off x="7894768" y="3068955"/>
            <a:ext cx="910828" cy="36004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423 included in the analysis</a:t>
            </a:r>
          </a:p>
        </p:txBody>
      </p:sp>
      <p:sp>
        <p:nvSpPr>
          <p:cNvPr id="31" name="Rectangle 30"/>
          <p:cNvSpPr/>
          <p:nvPr/>
        </p:nvSpPr>
        <p:spPr>
          <a:xfrm>
            <a:off x="7894767" y="2385811"/>
            <a:ext cx="910829" cy="55489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575" rIns="28575" rtlCol="0" anchor="ctr"/>
          <a:lstStyle/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211 Baseline SBP/DBP &lt;140/90 mmHg</a:t>
            </a:r>
          </a:p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621 follow-up &lt; 1 </a:t>
            </a:r>
            <a:r>
              <a:rPr lang="en-US" sz="656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 &gt; 12 m</a:t>
            </a:r>
          </a:p>
        </p:txBody>
      </p:sp>
      <p:cxnSp>
        <p:nvCxnSpPr>
          <p:cNvPr id="39" name="Straight Connector 38"/>
          <p:cNvCxnSpPr/>
          <p:nvPr/>
        </p:nvCxnSpPr>
        <p:spPr>
          <a:xfrm flipH="1">
            <a:off x="7398343" y="1746865"/>
            <a:ext cx="2668" cy="15631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Rectangle 46"/>
          <p:cNvSpPr/>
          <p:nvPr/>
        </p:nvSpPr>
        <p:spPr>
          <a:xfrm>
            <a:off x="6954133" y="3068955"/>
            <a:ext cx="910828" cy="36004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0 included in the analysis</a:t>
            </a:r>
          </a:p>
        </p:txBody>
      </p:sp>
      <p:sp>
        <p:nvSpPr>
          <p:cNvPr id="49" name="Rectangle 48"/>
          <p:cNvSpPr/>
          <p:nvPr/>
        </p:nvSpPr>
        <p:spPr>
          <a:xfrm>
            <a:off x="5073096" y="3068955"/>
            <a:ext cx="910828" cy="36004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74 included in the analysis</a:t>
            </a:r>
          </a:p>
        </p:txBody>
      </p:sp>
      <p:sp>
        <p:nvSpPr>
          <p:cNvPr id="50" name="Rectangle 49"/>
          <p:cNvSpPr/>
          <p:nvPr/>
        </p:nvSpPr>
        <p:spPr>
          <a:xfrm>
            <a:off x="4129601" y="3068955"/>
            <a:ext cx="910828" cy="36004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60 included in the analysis</a:t>
            </a:r>
          </a:p>
        </p:txBody>
      </p:sp>
      <p:sp>
        <p:nvSpPr>
          <p:cNvPr id="51" name="Rectangle 50"/>
          <p:cNvSpPr/>
          <p:nvPr/>
        </p:nvSpPr>
        <p:spPr>
          <a:xfrm>
            <a:off x="3192058" y="3068955"/>
            <a:ext cx="910828" cy="36004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70 included in the analysis</a:t>
            </a:r>
          </a:p>
        </p:txBody>
      </p:sp>
      <p:sp>
        <p:nvSpPr>
          <p:cNvPr id="52" name="Rectangle 51"/>
          <p:cNvSpPr/>
          <p:nvPr/>
        </p:nvSpPr>
        <p:spPr>
          <a:xfrm>
            <a:off x="2248563" y="3068955"/>
            <a:ext cx="910828" cy="36004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35 included in the analysis</a:t>
            </a:r>
          </a:p>
        </p:txBody>
      </p:sp>
      <p:sp>
        <p:nvSpPr>
          <p:cNvPr id="53" name="Rectangle 52"/>
          <p:cNvSpPr/>
          <p:nvPr/>
        </p:nvSpPr>
        <p:spPr>
          <a:xfrm>
            <a:off x="1311021" y="3068955"/>
            <a:ext cx="910828" cy="36004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29 included in the analysis</a:t>
            </a:r>
          </a:p>
        </p:txBody>
      </p:sp>
      <p:sp>
        <p:nvSpPr>
          <p:cNvPr id="54" name="Rectangle 53"/>
          <p:cNvSpPr/>
          <p:nvPr/>
        </p:nvSpPr>
        <p:spPr>
          <a:xfrm>
            <a:off x="6954133" y="1888194"/>
            <a:ext cx="910829" cy="36213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67 prescribed BB</a:t>
            </a:r>
          </a:p>
        </p:txBody>
      </p:sp>
      <p:sp>
        <p:nvSpPr>
          <p:cNvPr id="55" name="Rectangle 54"/>
          <p:cNvSpPr/>
          <p:nvPr/>
        </p:nvSpPr>
        <p:spPr>
          <a:xfrm>
            <a:off x="6954132" y="2390659"/>
            <a:ext cx="910829" cy="54520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575" rIns="28575" rtlCol="0" anchor="ctr"/>
          <a:lstStyle/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2 Baseline SBP/DBP &lt;140/90 mmHg</a:t>
            </a:r>
          </a:p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15 follow-up &lt; 1 </a:t>
            </a:r>
            <a:r>
              <a:rPr lang="en-US" sz="656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 &gt; 12 m</a:t>
            </a:r>
          </a:p>
        </p:txBody>
      </p:sp>
      <p:cxnSp>
        <p:nvCxnSpPr>
          <p:cNvPr id="56" name="Straight Connector 55"/>
          <p:cNvCxnSpPr/>
          <p:nvPr/>
        </p:nvCxnSpPr>
        <p:spPr>
          <a:xfrm flipH="1">
            <a:off x="6449596" y="1746865"/>
            <a:ext cx="2668" cy="15631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Rectangle 56"/>
          <p:cNvSpPr/>
          <p:nvPr/>
        </p:nvSpPr>
        <p:spPr>
          <a:xfrm>
            <a:off x="6010638" y="3068955"/>
            <a:ext cx="910828" cy="36004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28 included in the analysis</a:t>
            </a:r>
          </a:p>
        </p:txBody>
      </p:sp>
      <p:sp>
        <p:nvSpPr>
          <p:cNvPr id="58" name="Rectangle 57"/>
          <p:cNvSpPr/>
          <p:nvPr/>
        </p:nvSpPr>
        <p:spPr>
          <a:xfrm>
            <a:off x="6010638" y="1888194"/>
            <a:ext cx="910829" cy="36213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13 prescribed selective BB</a:t>
            </a:r>
          </a:p>
        </p:txBody>
      </p:sp>
      <p:sp>
        <p:nvSpPr>
          <p:cNvPr id="59" name="Rectangle 58"/>
          <p:cNvSpPr/>
          <p:nvPr/>
        </p:nvSpPr>
        <p:spPr>
          <a:xfrm>
            <a:off x="6010637" y="2390659"/>
            <a:ext cx="910829" cy="54520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575" rIns="28575" rtlCol="0" anchor="ctr"/>
          <a:lstStyle/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45 Baseline SBP/DBP &lt;140/90 mmHg</a:t>
            </a:r>
          </a:p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40 follow-up &lt; 1 </a:t>
            </a:r>
            <a:r>
              <a:rPr lang="en-US" sz="656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 &gt; 12 m</a:t>
            </a:r>
          </a:p>
        </p:txBody>
      </p:sp>
      <p:sp>
        <p:nvSpPr>
          <p:cNvPr id="60" name="Rectangle 59"/>
          <p:cNvSpPr/>
          <p:nvPr/>
        </p:nvSpPr>
        <p:spPr>
          <a:xfrm>
            <a:off x="5073095" y="1888194"/>
            <a:ext cx="910829" cy="36213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66 prescribed ARB</a:t>
            </a:r>
          </a:p>
        </p:txBody>
      </p:sp>
      <p:sp>
        <p:nvSpPr>
          <p:cNvPr id="61" name="Rectangle 60"/>
          <p:cNvSpPr/>
          <p:nvPr/>
        </p:nvSpPr>
        <p:spPr>
          <a:xfrm>
            <a:off x="5073095" y="2390659"/>
            <a:ext cx="910829" cy="54520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575" rIns="28575" rtlCol="0" anchor="ctr"/>
          <a:lstStyle/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35 Baseline SBP/DBP &lt;140/90 mmHg</a:t>
            </a:r>
          </a:p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57 follow-up &lt; 1 </a:t>
            </a:r>
            <a:r>
              <a:rPr lang="en-US" sz="656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 &gt; 12 m</a:t>
            </a:r>
          </a:p>
        </p:txBody>
      </p:sp>
      <p:sp>
        <p:nvSpPr>
          <p:cNvPr id="62" name="Rectangle 61"/>
          <p:cNvSpPr/>
          <p:nvPr/>
        </p:nvSpPr>
        <p:spPr>
          <a:xfrm>
            <a:off x="4129600" y="1888194"/>
            <a:ext cx="910829" cy="36213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35 prescribed ACE inhibitor</a:t>
            </a:r>
          </a:p>
        </p:txBody>
      </p:sp>
      <p:sp>
        <p:nvSpPr>
          <p:cNvPr id="63" name="Rectangle 62"/>
          <p:cNvSpPr/>
          <p:nvPr/>
        </p:nvSpPr>
        <p:spPr>
          <a:xfrm>
            <a:off x="4129599" y="2390659"/>
            <a:ext cx="910829" cy="54520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575" rIns="28575" rtlCol="0" anchor="ctr"/>
          <a:lstStyle/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96 Baseline SBP/DBP &lt;140/90 mmHg</a:t>
            </a:r>
          </a:p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79 follow-up &lt; 1 </a:t>
            </a:r>
            <a:r>
              <a:rPr lang="en-US" sz="656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 &gt; 12 m</a:t>
            </a:r>
          </a:p>
        </p:txBody>
      </p:sp>
      <p:sp>
        <p:nvSpPr>
          <p:cNvPr id="64" name="Rectangle 63"/>
          <p:cNvSpPr/>
          <p:nvPr/>
        </p:nvSpPr>
        <p:spPr>
          <a:xfrm>
            <a:off x="3192058" y="1888194"/>
            <a:ext cx="910829" cy="36213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50 prescribed CCB</a:t>
            </a:r>
          </a:p>
        </p:txBody>
      </p:sp>
      <p:sp>
        <p:nvSpPr>
          <p:cNvPr id="65" name="Rectangle 64"/>
          <p:cNvSpPr/>
          <p:nvPr/>
        </p:nvSpPr>
        <p:spPr>
          <a:xfrm>
            <a:off x="3192057" y="2390659"/>
            <a:ext cx="910829" cy="54520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575" rIns="28575" rtlCol="0" anchor="ctr"/>
          <a:lstStyle/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22 Baseline SBP/DBP &lt;140/90 mmHg</a:t>
            </a:r>
          </a:p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58 follow-up &lt; 1 </a:t>
            </a:r>
            <a:r>
              <a:rPr lang="en-US" sz="656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 &gt; 12 m</a:t>
            </a:r>
          </a:p>
        </p:txBody>
      </p:sp>
      <p:sp>
        <p:nvSpPr>
          <p:cNvPr id="66" name="Rectangle 65"/>
          <p:cNvSpPr/>
          <p:nvPr/>
        </p:nvSpPr>
        <p:spPr>
          <a:xfrm>
            <a:off x="2248563" y="1888194"/>
            <a:ext cx="910829" cy="36213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83 prescribed THZ</a:t>
            </a:r>
          </a:p>
        </p:txBody>
      </p:sp>
      <p:sp>
        <p:nvSpPr>
          <p:cNvPr id="67" name="Rectangle 66"/>
          <p:cNvSpPr/>
          <p:nvPr/>
        </p:nvSpPr>
        <p:spPr>
          <a:xfrm>
            <a:off x="2248562" y="2390659"/>
            <a:ext cx="910829" cy="54520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575" rIns="28575" rtlCol="0" anchor="ctr"/>
          <a:lstStyle/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1 Baseline SBP/DBP &lt;140/90 mmHg</a:t>
            </a:r>
          </a:p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47 follow-up &lt; 1 </a:t>
            </a:r>
            <a:r>
              <a:rPr lang="en-US" sz="656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 &gt; 12 m</a:t>
            </a:r>
          </a:p>
        </p:txBody>
      </p:sp>
      <p:sp>
        <p:nvSpPr>
          <p:cNvPr id="68" name="Rectangle 67"/>
          <p:cNvSpPr/>
          <p:nvPr/>
        </p:nvSpPr>
        <p:spPr>
          <a:xfrm>
            <a:off x="1311020" y="1888194"/>
            <a:ext cx="910829" cy="36213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22 prescribed ARB+THZ</a:t>
            </a:r>
          </a:p>
        </p:txBody>
      </p:sp>
      <p:sp>
        <p:nvSpPr>
          <p:cNvPr id="69" name="Rectangle 68"/>
          <p:cNvSpPr/>
          <p:nvPr/>
        </p:nvSpPr>
        <p:spPr>
          <a:xfrm>
            <a:off x="1311020" y="2390659"/>
            <a:ext cx="910829" cy="54520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575" rIns="28575" rtlCol="0" anchor="ctr"/>
          <a:lstStyle/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72 Baseline SBP/DBP &lt;140/90 mmHg</a:t>
            </a:r>
          </a:p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21 follow-up &lt; 1 </a:t>
            </a:r>
            <a:r>
              <a:rPr lang="en-US" sz="656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 &gt; 12 m</a:t>
            </a:r>
          </a:p>
        </p:txBody>
      </p:sp>
      <p:cxnSp>
        <p:nvCxnSpPr>
          <p:cNvPr id="46" name="Straight Connector 45"/>
          <p:cNvCxnSpPr/>
          <p:nvPr/>
        </p:nvCxnSpPr>
        <p:spPr>
          <a:xfrm flipH="1">
            <a:off x="4514789" y="1529867"/>
            <a:ext cx="959684" cy="68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Rectangle 47"/>
          <p:cNvSpPr/>
          <p:nvPr/>
        </p:nvSpPr>
        <p:spPr>
          <a:xfrm>
            <a:off x="4818738" y="1323286"/>
            <a:ext cx="1191899" cy="36221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2,903 prescribed multiple antihypertensive therapies and/or taking other class</a:t>
            </a:r>
          </a:p>
        </p:txBody>
      </p:sp>
      <p:sp>
        <p:nvSpPr>
          <p:cNvPr id="42" name="Rectangle 41"/>
          <p:cNvSpPr/>
          <p:nvPr/>
        </p:nvSpPr>
        <p:spPr>
          <a:xfrm>
            <a:off x="2498062" y="1218703"/>
            <a:ext cx="1702873" cy="36221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4,887 excluded for comorbidities: heart failure, renal failure, liver failure, pulmonary hypertension, COPD, or cardiomyopathy</a:t>
            </a:r>
          </a:p>
        </p:txBody>
      </p:sp>
      <p:cxnSp>
        <p:nvCxnSpPr>
          <p:cNvPr id="45" name="Straight Connector 44"/>
          <p:cNvCxnSpPr/>
          <p:nvPr/>
        </p:nvCxnSpPr>
        <p:spPr>
          <a:xfrm flipH="1">
            <a:off x="825295" y="1746863"/>
            <a:ext cx="1141" cy="160478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Rectangle 69"/>
          <p:cNvSpPr/>
          <p:nvPr/>
        </p:nvSpPr>
        <p:spPr>
          <a:xfrm>
            <a:off x="370191" y="3068955"/>
            <a:ext cx="910828" cy="36004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03 included in the analysis</a:t>
            </a:r>
          </a:p>
        </p:txBody>
      </p:sp>
      <p:sp>
        <p:nvSpPr>
          <p:cNvPr id="71" name="Rectangle 70"/>
          <p:cNvSpPr/>
          <p:nvPr/>
        </p:nvSpPr>
        <p:spPr>
          <a:xfrm>
            <a:off x="370190" y="1888194"/>
            <a:ext cx="910829" cy="36213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58 prescribed ACE+THZ</a:t>
            </a:r>
          </a:p>
        </p:txBody>
      </p:sp>
      <p:sp>
        <p:nvSpPr>
          <p:cNvPr id="72" name="Rectangle 71"/>
          <p:cNvSpPr/>
          <p:nvPr/>
        </p:nvSpPr>
        <p:spPr>
          <a:xfrm>
            <a:off x="370190" y="2390659"/>
            <a:ext cx="910829" cy="54520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575" rIns="28575" rtlCol="0" anchor="ctr"/>
          <a:lstStyle/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97 Baseline SBP/DBP &lt;140/90 mmHg</a:t>
            </a:r>
          </a:p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58 follow-up &lt; 1 </a:t>
            </a:r>
            <a:r>
              <a:rPr lang="en-US" sz="656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 &gt; 12 m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62EF9652-C0B9-4F1D-B616-3C7D85C2B052}"/>
              </a:ext>
            </a:extLst>
          </p:cNvPr>
          <p:cNvSpPr txBox="1"/>
          <p:nvPr/>
        </p:nvSpPr>
        <p:spPr>
          <a:xfrm>
            <a:off x="338403" y="105468"/>
            <a:ext cx="8467194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A1.  Database flow chart for exclusion numbers and sample sizes for each drug class in white and black patients</a:t>
            </a: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EA77F315-873F-4310-92C0-72CA0FE0A6A0}"/>
              </a:ext>
            </a:extLst>
          </p:cNvPr>
          <p:cNvCxnSpPr/>
          <p:nvPr/>
        </p:nvCxnSpPr>
        <p:spPr>
          <a:xfrm flipH="1">
            <a:off x="1722293" y="4984882"/>
            <a:ext cx="2668" cy="15631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E6D121E5-74A2-47E4-BC03-82F8C01F53BA}"/>
              </a:ext>
            </a:extLst>
          </p:cNvPr>
          <p:cNvCxnSpPr/>
          <p:nvPr/>
        </p:nvCxnSpPr>
        <p:spPr>
          <a:xfrm flipH="1">
            <a:off x="3635717" y="4984883"/>
            <a:ext cx="2668" cy="15631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29BAAA37-C70B-4789-ABF8-1E097B17FFB7}"/>
              </a:ext>
            </a:extLst>
          </p:cNvPr>
          <p:cNvCxnSpPr/>
          <p:nvPr/>
        </p:nvCxnSpPr>
        <p:spPr>
          <a:xfrm flipH="1">
            <a:off x="2644493" y="4984882"/>
            <a:ext cx="2668" cy="15631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04F880BF-AA74-46EB-82AF-FDB29C28529A}"/>
              </a:ext>
            </a:extLst>
          </p:cNvPr>
          <p:cNvCxnSpPr/>
          <p:nvPr/>
        </p:nvCxnSpPr>
        <p:spPr>
          <a:xfrm flipH="1">
            <a:off x="4538940" y="4984884"/>
            <a:ext cx="2668" cy="15631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1D30995D-8F63-4210-BE19-8C3202E332A9}"/>
              </a:ext>
            </a:extLst>
          </p:cNvPr>
          <p:cNvCxnSpPr/>
          <p:nvPr/>
        </p:nvCxnSpPr>
        <p:spPr>
          <a:xfrm flipH="1">
            <a:off x="6446435" y="4984884"/>
            <a:ext cx="2668" cy="15631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3139E758-3118-4314-8DD9-7C698B015CF1}"/>
              </a:ext>
            </a:extLst>
          </p:cNvPr>
          <p:cNvCxnSpPr/>
          <p:nvPr/>
        </p:nvCxnSpPr>
        <p:spPr>
          <a:xfrm flipH="1">
            <a:off x="7373557" y="4984885"/>
            <a:ext cx="2668" cy="15631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A198D3DC-A892-4CCF-8617-EA59AAD46F38}"/>
              </a:ext>
            </a:extLst>
          </p:cNvPr>
          <p:cNvCxnSpPr/>
          <p:nvPr/>
        </p:nvCxnSpPr>
        <p:spPr>
          <a:xfrm flipH="1">
            <a:off x="8322058" y="4983667"/>
            <a:ext cx="11602" cy="156553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6AC85783-E547-48F0-BBC4-7DBC2929893B}"/>
              </a:ext>
            </a:extLst>
          </p:cNvPr>
          <p:cNvCxnSpPr/>
          <p:nvPr/>
        </p:nvCxnSpPr>
        <p:spPr>
          <a:xfrm>
            <a:off x="4538940" y="4195385"/>
            <a:ext cx="0" cy="78101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Rectangle 82">
            <a:extLst>
              <a:ext uri="{FF2B5EF4-FFF2-40B4-BE49-F238E27FC236}">
                <a16:creationId xmlns:a16="http://schemas.microsoft.com/office/drawing/2014/main" id="{35621D6D-A4A7-468C-B07B-58BBFDBA0133}"/>
              </a:ext>
            </a:extLst>
          </p:cNvPr>
          <p:cNvSpPr/>
          <p:nvPr/>
        </p:nvSpPr>
        <p:spPr>
          <a:xfrm>
            <a:off x="3894499" y="3935485"/>
            <a:ext cx="1283941" cy="36221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9,474 total patients with clinical HTN diagnosis</a:t>
            </a:r>
          </a:p>
        </p:txBody>
      </p: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E87D6A64-5745-46C7-88AC-B56AB825C365}"/>
              </a:ext>
            </a:extLst>
          </p:cNvPr>
          <p:cNvCxnSpPr/>
          <p:nvPr/>
        </p:nvCxnSpPr>
        <p:spPr>
          <a:xfrm>
            <a:off x="777776" y="4981249"/>
            <a:ext cx="7555883" cy="484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Rectangle 85">
            <a:extLst>
              <a:ext uri="{FF2B5EF4-FFF2-40B4-BE49-F238E27FC236}">
                <a16:creationId xmlns:a16="http://schemas.microsoft.com/office/drawing/2014/main" id="{2D781098-87FF-41BC-88B3-7834FF7BB883}"/>
              </a:ext>
            </a:extLst>
          </p:cNvPr>
          <p:cNvSpPr/>
          <p:nvPr/>
        </p:nvSpPr>
        <p:spPr>
          <a:xfrm>
            <a:off x="7878246" y="5123621"/>
            <a:ext cx="910829" cy="36213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3,415 not prescribed antihypertensive drug (Untreated)</a:t>
            </a:r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936B67E5-11D2-4209-9F0B-F836AC0FE105}"/>
              </a:ext>
            </a:extLst>
          </p:cNvPr>
          <p:cNvSpPr/>
          <p:nvPr/>
        </p:nvSpPr>
        <p:spPr>
          <a:xfrm>
            <a:off x="7878246" y="6306426"/>
            <a:ext cx="910828" cy="38311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191 patients included in the analysis</a:t>
            </a: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10EEAB74-B5DA-4F2B-BD58-B1E6E832445F}"/>
              </a:ext>
            </a:extLst>
          </p:cNvPr>
          <p:cNvSpPr/>
          <p:nvPr/>
        </p:nvSpPr>
        <p:spPr>
          <a:xfrm>
            <a:off x="7878245" y="5626083"/>
            <a:ext cx="910829" cy="5492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575" rIns="28575" rtlCol="0" anchor="ctr"/>
          <a:lstStyle/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205 Baseline SBP/DBP &lt;140/90 mmHg</a:t>
            </a:r>
          </a:p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19 follow-up &lt; 1 </a:t>
            </a:r>
            <a:r>
              <a:rPr lang="en-US" sz="656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 &gt; 12 m</a:t>
            </a:r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788289CF-EF36-42E0-8674-240A52C20144}"/>
              </a:ext>
            </a:extLst>
          </p:cNvPr>
          <p:cNvSpPr/>
          <p:nvPr/>
        </p:nvSpPr>
        <p:spPr>
          <a:xfrm>
            <a:off x="6932416" y="6306426"/>
            <a:ext cx="910828" cy="38311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6 patients included in the analysis</a:t>
            </a:r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9088AFCB-0642-4913-8338-F30E6EDBF20A}"/>
              </a:ext>
            </a:extLst>
          </p:cNvPr>
          <p:cNvSpPr/>
          <p:nvPr/>
        </p:nvSpPr>
        <p:spPr>
          <a:xfrm>
            <a:off x="4088845" y="6306426"/>
            <a:ext cx="910828" cy="38311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29 patients included in the analysis</a:t>
            </a:r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10CE1F09-2042-4F6A-A406-F3C99B33E648}"/>
              </a:ext>
            </a:extLst>
          </p:cNvPr>
          <p:cNvSpPr/>
          <p:nvPr/>
        </p:nvSpPr>
        <p:spPr>
          <a:xfrm>
            <a:off x="3143700" y="6306426"/>
            <a:ext cx="910828" cy="38311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645 patients included in the analysis</a:t>
            </a:r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AFBE3780-7CC9-43CA-AE1E-D2F11C2D8A91}"/>
              </a:ext>
            </a:extLst>
          </p:cNvPr>
          <p:cNvSpPr/>
          <p:nvPr/>
        </p:nvSpPr>
        <p:spPr>
          <a:xfrm>
            <a:off x="2199526" y="6306426"/>
            <a:ext cx="910828" cy="38311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04 patients included in the analysis</a:t>
            </a:r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A0CC0466-045D-4A69-8901-EE5772E51FBF}"/>
              </a:ext>
            </a:extLst>
          </p:cNvPr>
          <p:cNvSpPr/>
          <p:nvPr/>
        </p:nvSpPr>
        <p:spPr>
          <a:xfrm>
            <a:off x="1254854" y="6306426"/>
            <a:ext cx="910828" cy="38311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11 patients included in the analysis</a:t>
            </a:r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DCFD9A27-D489-4230-802C-97DE89D266F9}"/>
              </a:ext>
            </a:extLst>
          </p:cNvPr>
          <p:cNvSpPr/>
          <p:nvPr/>
        </p:nvSpPr>
        <p:spPr>
          <a:xfrm>
            <a:off x="6932416" y="5123621"/>
            <a:ext cx="910829" cy="36213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35 prescribed BB</a:t>
            </a:r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7E506216-DC8A-4FD4-A184-A2602BEAAEEC}"/>
              </a:ext>
            </a:extLst>
          </p:cNvPr>
          <p:cNvSpPr/>
          <p:nvPr/>
        </p:nvSpPr>
        <p:spPr>
          <a:xfrm>
            <a:off x="6932415" y="5628129"/>
            <a:ext cx="910829" cy="54520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575" rIns="28575" rtlCol="0" anchor="ctr"/>
          <a:lstStyle/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62 Baseline SBP/DBP &lt;140/90 mmHg</a:t>
            </a:r>
          </a:p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17 follow-up &lt; 1 </a:t>
            </a:r>
            <a:r>
              <a:rPr lang="en-US" sz="656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 &gt; 12 m</a:t>
            </a:r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8F6E25B1-5E8A-4A5D-BBED-8F7888B7D906}"/>
              </a:ext>
            </a:extLst>
          </p:cNvPr>
          <p:cNvSpPr/>
          <p:nvPr/>
        </p:nvSpPr>
        <p:spPr>
          <a:xfrm>
            <a:off x="5986585" y="6306426"/>
            <a:ext cx="910828" cy="38311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70 patients included in the analysis</a:t>
            </a:r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BC3F76E9-8A82-4CCB-9BA4-69854809793B}"/>
              </a:ext>
            </a:extLst>
          </p:cNvPr>
          <p:cNvSpPr/>
          <p:nvPr/>
        </p:nvSpPr>
        <p:spPr>
          <a:xfrm>
            <a:off x="5986585" y="5123621"/>
            <a:ext cx="910829" cy="36213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78 prescribed selective BB</a:t>
            </a:r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9262C338-A696-4715-8A1D-B4730A391743}"/>
              </a:ext>
            </a:extLst>
          </p:cNvPr>
          <p:cNvSpPr/>
          <p:nvPr/>
        </p:nvSpPr>
        <p:spPr>
          <a:xfrm>
            <a:off x="5986584" y="5628129"/>
            <a:ext cx="910829" cy="54520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575" rIns="28575" rtlCol="0" anchor="ctr"/>
          <a:lstStyle/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4 Baseline SBP/DBP &lt;140/90 mmHg</a:t>
            </a:r>
          </a:p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54 follow-up &lt; 1 </a:t>
            </a:r>
            <a:r>
              <a:rPr lang="en-US" sz="656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 &gt; 12 m</a:t>
            </a:r>
          </a:p>
        </p:txBody>
      </p: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F37F695F-E6D4-4E33-89ED-513C0ADCA26D}"/>
              </a:ext>
            </a:extLst>
          </p:cNvPr>
          <p:cNvCxnSpPr/>
          <p:nvPr/>
        </p:nvCxnSpPr>
        <p:spPr>
          <a:xfrm flipH="1">
            <a:off x="5488066" y="4987312"/>
            <a:ext cx="2668" cy="15631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Rectangle 99">
            <a:extLst>
              <a:ext uri="{FF2B5EF4-FFF2-40B4-BE49-F238E27FC236}">
                <a16:creationId xmlns:a16="http://schemas.microsoft.com/office/drawing/2014/main" id="{1446931D-5D41-4548-9446-0D204D039986}"/>
              </a:ext>
            </a:extLst>
          </p:cNvPr>
          <p:cNvSpPr/>
          <p:nvPr/>
        </p:nvSpPr>
        <p:spPr>
          <a:xfrm>
            <a:off x="5036257" y="5123621"/>
            <a:ext cx="910829" cy="36213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37 prescribed ARB</a:t>
            </a:r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BA4D5ED2-A43C-44CD-94EB-14416BF5366C}"/>
              </a:ext>
            </a:extLst>
          </p:cNvPr>
          <p:cNvSpPr/>
          <p:nvPr/>
        </p:nvSpPr>
        <p:spPr>
          <a:xfrm>
            <a:off x="5036255" y="5628129"/>
            <a:ext cx="910829" cy="54520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575" rIns="28575" rtlCol="0" anchor="ctr"/>
          <a:lstStyle/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7 Baseline SBP/DBP &lt;140/90 mmHg</a:t>
            </a:r>
          </a:p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39 follow-up &lt; 1 </a:t>
            </a:r>
            <a:r>
              <a:rPr lang="en-US" sz="656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 &gt; 12 m</a:t>
            </a:r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0A9A1262-569C-4741-9955-2C7EBC325A7E}"/>
              </a:ext>
            </a:extLst>
          </p:cNvPr>
          <p:cNvSpPr/>
          <p:nvPr/>
        </p:nvSpPr>
        <p:spPr>
          <a:xfrm>
            <a:off x="5036257" y="6306426"/>
            <a:ext cx="910828" cy="38311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41 patients included in the analysis</a:t>
            </a:r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id="{42E6C8C9-983D-4AFA-9F5B-6CACDC924E31}"/>
              </a:ext>
            </a:extLst>
          </p:cNvPr>
          <p:cNvSpPr/>
          <p:nvPr/>
        </p:nvSpPr>
        <p:spPr>
          <a:xfrm>
            <a:off x="4088844" y="5123621"/>
            <a:ext cx="910829" cy="36213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307 prescribed ACE inhibitor</a:t>
            </a:r>
          </a:p>
        </p:txBody>
      </p:sp>
      <p:sp>
        <p:nvSpPr>
          <p:cNvPr id="104" name="Rectangle 103">
            <a:extLst>
              <a:ext uri="{FF2B5EF4-FFF2-40B4-BE49-F238E27FC236}">
                <a16:creationId xmlns:a16="http://schemas.microsoft.com/office/drawing/2014/main" id="{01697218-CFE7-4375-8A87-224CA6BC15B8}"/>
              </a:ext>
            </a:extLst>
          </p:cNvPr>
          <p:cNvSpPr/>
          <p:nvPr/>
        </p:nvSpPr>
        <p:spPr>
          <a:xfrm>
            <a:off x="4088842" y="5628129"/>
            <a:ext cx="910829" cy="54520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575" rIns="28575" rtlCol="0" anchor="ctr"/>
          <a:lstStyle/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83 Baseline SBP/DBP &lt;140/90 mmHg</a:t>
            </a:r>
          </a:p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95 follow-up &lt; 1 </a:t>
            </a:r>
            <a:r>
              <a:rPr lang="en-US" sz="656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 &gt; 12 m</a:t>
            </a:r>
          </a:p>
        </p:txBody>
      </p:sp>
      <p:sp>
        <p:nvSpPr>
          <p:cNvPr id="105" name="Rectangle 104">
            <a:extLst>
              <a:ext uri="{FF2B5EF4-FFF2-40B4-BE49-F238E27FC236}">
                <a16:creationId xmlns:a16="http://schemas.microsoft.com/office/drawing/2014/main" id="{A8E6EEC6-BB5D-4F6B-AB84-90A8BAFBD06B}"/>
              </a:ext>
            </a:extLst>
          </p:cNvPr>
          <p:cNvSpPr/>
          <p:nvPr/>
        </p:nvSpPr>
        <p:spPr>
          <a:xfrm>
            <a:off x="3143699" y="5123621"/>
            <a:ext cx="910829" cy="36213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49 prescribed CCB</a:t>
            </a:r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A078C6C3-485D-445F-8663-2F00AE6631D0}"/>
              </a:ext>
            </a:extLst>
          </p:cNvPr>
          <p:cNvSpPr/>
          <p:nvPr/>
        </p:nvSpPr>
        <p:spPr>
          <a:xfrm>
            <a:off x="3143698" y="5628129"/>
            <a:ext cx="910829" cy="54520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575" rIns="28575" rtlCol="0" anchor="ctr"/>
          <a:lstStyle/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60 Baseline SBP/DBP &lt;140/90 mmHg</a:t>
            </a:r>
          </a:p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244 follow-up &lt; 1 </a:t>
            </a:r>
            <a:r>
              <a:rPr lang="en-US" sz="656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 &gt; 12 m</a:t>
            </a:r>
          </a:p>
        </p:txBody>
      </p:sp>
      <p:sp>
        <p:nvSpPr>
          <p:cNvPr id="107" name="Rectangle 106">
            <a:extLst>
              <a:ext uri="{FF2B5EF4-FFF2-40B4-BE49-F238E27FC236}">
                <a16:creationId xmlns:a16="http://schemas.microsoft.com/office/drawing/2014/main" id="{686EF6E0-D536-4A24-817F-C968475D6332}"/>
              </a:ext>
            </a:extLst>
          </p:cNvPr>
          <p:cNvSpPr/>
          <p:nvPr/>
        </p:nvSpPr>
        <p:spPr>
          <a:xfrm>
            <a:off x="2199525" y="5123621"/>
            <a:ext cx="910829" cy="36213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27 prescribed THZ</a:t>
            </a:r>
          </a:p>
        </p:txBody>
      </p:sp>
      <p:sp>
        <p:nvSpPr>
          <p:cNvPr id="108" name="Rectangle 107">
            <a:extLst>
              <a:ext uri="{FF2B5EF4-FFF2-40B4-BE49-F238E27FC236}">
                <a16:creationId xmlns:a16="http://schemas.microsoft.com/office/drawing/2014/main" id="{09EF4537-C977-4CC6-ACE6-B6DAF47351F3}"/>
              </a:ext>
            </a:extLst>
          </p:cNvPr>
          <p:cNvSpPr/>
          <p:nvPr/>
        </p:nvSpPr>
        <p:spPr>
          <a:xfrm>
            <a:off x="2199525" y="5628129"/>
            <a:ext cx="910829" cy="54520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575" rIns="28575" rtlCol="0" anchor="ctr"/>
          <a:lstStyle/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85 Baseline SBP/DBP &lt;140/90 mmHg</a:t>
            </a:r>
          </a:p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138 follow-up &lt; 1 </a:t>
            </a:r>
            <a:r>
              <a:rPr lang="en-US" sz="656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 &gt; 12 m</a:t>
            </a:r>
          </a:p>
        </p:txBody>
      </p:sp>
      <p:sp>
        <p:nvSpPr>
          <p:cNvPr id="109" name="Rectangle 108">
            <a:extLst>
              <a:ext uri="{FF2B5EF4-FFF2-40B4-BE49-F238E27FC236}">
                <a16:creationId xmlns:a16="http://schemas.microsoft.com/office/drawing/2014/main" id="{0AC7FCFA-34B3-4BBA-9C36-3769F8786888}"/>
              </a:ext>
            </a:extLst>
          </p:cNvPr>
          <p:cNvSpPr/>
          <p:nvPr/>
        </p:nvSpPr>
        <p:spPr>
          <a:xfrm>
            <a:off x="1254853" y="5123621"/>
            <a:ext cx="910829" cy="36213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15 prescribed ARB+THZ</a:t>
            </a:r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5D807D82-9117-4BA2-B873-C3E6D334A6DD}"/>
              </a:ext>
            </a:extLst>
          </p:cNvPr>
          <p:cNvSpPr/>
          <p:nvPr/>
        </p:nvSpPr>
        <p:spPr>
          <a:xfrm>
            <a:off x="1254852" y="5628129"/>
            <a:ext cx="910829" cy="54520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575" rIns="28575" rtlCol="0" anchor="ctr"/>
          <a:lstStyle/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43 Baseline SBP/DBP &lt;140/90 mmHg</a:t>
            </a:r>
          </a:p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61 follow-up &lt; 1 </a:t>
            </a:r>
            <a:r>
              <a:rPr lang="en-US" sz="656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 &gt; 12 m</a:t>
            </a:r>
          </a:p>
        </p:txBody>
      </p: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B2CAD890-27F2-49B0-AF48-50170122C1A8}"/>
              </a:ext>
            </a:extLst>
          </p:cNvPr>
          <p:cNvCxnSpPr/>
          <p:nvPr/>
        </p:nvCxnSpPr>
        <p:spPr>
          <a:xfrm>
            <a:off x="4536470" y="4722490"/>
            <a:ext cx="106890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Rectangle 111">
            <a:extLst>
              <a:ext uri="{FF2B5EF4-FFF2-40B4-BE49-F238E27FC236}">
                <a16:creationId xmlns:a16="http://schemas.microsoft.com/office/drawing/2014/main" id="{A082A5C6-087C-41CB-9D76-DE93DB064B20}"/>
              </a:ext>
            </a:extLst>
          </p:cNvPr>
          <p:cNvSpPr/>
          <p:nvPr/>
        </p:nvSpPr>
        <p:spPr>
          <a:xfrm>
            <a:off x="4894034" y="4529426"/>
            <a:ext cx="1191899" cy="36221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6,830 prescribed multiple antihypertensive therapies and/or taking other class</a:t>
            </a:r>
          </a:p>
        </p:txBody>
      </p: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E3B9FDC9-F5FC-4301-A8B8-9BB7A45E8D5C}"/>
              </a:ext>
            </a:extLst>
          </p:cNvPr>
          <p:cNvCxnSpPr/>
          <p:nvPr/>
        </p:nvCxnSpPr>
        <p:spPr>
          <a:xfrm flipH="1">
            <a:off x="3577187" y="4564101"/>
            <a:ext cx="959684" cy="68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Rectangle 113">
            <a:extLst>
              <a:ext uri="{FF2B5EF4-FFF2-40B4-BE49-F238E27FC236}">
                <a16:creationId xmlns:a16="http://schemas.microsoft.com/office/drawing/2014/main" id="{A358514D-A0F5-4210-83D9-D3859CC73749}"/>
              </a:ext>
            </a:extLst>
          </p:cNvPr>
          <p:cNvSpPr/>
          <p:nvPr/>
        </p:nvSpPr>
        <p:spPr>
          <a:xfrm>
            <a:off x="2496886" y="4388052"/>
            <a:ext cx="1686959" cy="36221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0,157 excluded for comorbidities: heart failure, renal failure, liver failure, pulmonary hypertension, COPD, or cardiomyopathy</a:t>
            </a:r>
          </a:p>
        </p:txBody>
      </p: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B3527551-0595-4929-B21D-36F5B73B2373}"/>
              </a:ext>
            </a:extLst>
          </p:cNvPr>
          <p:cNvCxnSpPr/>
          <p:nvPr/>
        </p:nvCxnSpPr>
        <p:spPr>
          <a:xfrm flipH="1">
            <a:off x="777776" y="4984882"/>
            <a:ext cx="2668" cy="15631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Rectangle 115">
            <a:extLst>
              <a:ext uri="{FF2B5EF4-FFF2-40B4-BE49-F238E27FC236}">
                <a16:creationId xmlns:a16="http://schemas.microsoft.com/office/drawing/2014/main" id="{05735C71-294A-40F2-8FD1-C69A91135F24}"/>
              </a:ext>
            </a:extLst>
          </p:cNvPr>
          <p:cNvSpPr/>
          <p:nvPr/>
        </p:nvSpPr>
        <p:spPr>
          <a:xfrm>
            <a:off x="310337" y="6306426"/>
            <a:ext cx="910828" cy="38311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07 patients included in the analysis</a:t>
            </a:r>
          </a:p>
        </p:txBody>
      </p:sp>
      <p:sp>
        <p:nvSpPr>
          <p:cNvPr id="117" name="Rectangle 116">
            <a:extLst>
              <a:ext uri="{FF2B5EF4-FFF2-40B4-BE49-F238E27FC236}">
                <a16:creationId xmlns:a16="http://schemas.microsoft.com/office/drawing/2014/main" id="{29C8D040-A0E0-4DF6-B5F7-ADE48E3D1206}"/>
              </a:ext>
            </a:extLst>
          </p:cNvPr>
          <p:cNvSpPr/>
          <p:nvPr/>
        </p:nvSpPr>
        <p:spPr>
          <a:xfrm>
            <a:off x="310337" y="5123621"/>
            <a:ext cx="910829" cy="36213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724 prescribed ACE+THZ</a:t>
            </a:r>
          </a:p>
        </p:txBody>
      </p:sp>
      <p:sp>
        <p:nvSpPr>
          <p:cNvPr id="118" name="Rectangle 117">
            <a:extLst>
              <a:ext uri="{FF2B5EF4-FFF2-40B4-BE49-F238E27FC236}">
                <a16:creationId xmlns:a16="http://schemas.microsoft.com/office/drawing/2014/main" id="{5DE910A3-0A4A-45E4-A0C4-F5E6FF8BF706}"/>
              </a:ext>
            </a:extLst>
          </p:cNvPr>
          <p:cNvSpPr/>
          <p:nvPr/>
        </p:nvSpPr>
        <p:spPr>
          <a:xfrm>
            <a:off x="310336" y="5628129"/>
            <a:ext cx="910829" cy="54520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575" rIns="28575" rtlCol="0" anchor="ctr"/>
          <a:lstStyle/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32 Baseline SBP/DBP &lt;140/90 mmHg</a:t>
            </a:r>
          </a:p>
          <a:p>
            <a:pPr marL="290700" indent="-290700"/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185 follow-up &lt; 1 </a:t>
            </a:r>
            <a:r>
              <a:rPr lang="en-US" sz="656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sz="656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 &gt; 12 m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619338F1-D54F-47CA-ABAD-357530B4FBE2}"/>
              </a:ext>
            </a:extLst>
          </p:cNvPr>
          <p:cNvSpPr txBox="1"/>
          <p:nvPr/>
        </p:nvSpPr>
        <p:spPr>
          <a:xfrm>
            <a:off x="4283046" y="3649991"/>
            <a:ext cx="545342" cy="3779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ack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65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696539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BD8A312A-3AFE-43F6-AA6A-116493A77D2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174" t="31477" r="23303" b="6581"/>
          <a:stretch/>
        </p:blipFill>
        <p:spPr>
          <a:xfrm>
            <a:off x="1842200" y="2067809"/>
            <a:ext cx="5459599" cy="27223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39517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2366133-4C94-4A5A-9411-8BAC62C9AAF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936"/>
          <a:stretch/>
        </p:blipFill>
        <p:spPr>
          <a:xfrm>
            <a:off x="1261424" y="619125"/>
            <a:ext cx="6621151" cy="610552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C397B77-D7C4-4203-8B59-4D996633BC45}"/>
              </a:ext>
            </a:extLst>
          </p:cNvPr>
          <p:cNvSpPr txBox="1"/>
          <p:nvPr/>
        </p:nvSpPr>
        <p:spPr>
          <a:xfrm>
            <a:off x="1061466" y="95905"/>
            <a:ext cx="7021065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A1.  Study population and drug prescriptions by specific drug types and dosages within each class.</a:t>
            </a:r>
          </a:p>
        </p:txBody>
      </p:sp>
    </p:spTree>
    <p:extLst>
      <p:ext uri="{BB962C8B-B14F-4D97-AF65-F5344CB8AC3E}">
        <p14:creationId xmlns:p14="http://schemas.microsoft.com/office/powerpoint/2010/main" val="24550054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823</TotalTime>
  <Words>619</Words>
  <Application>Microsoft Office PowerPoint</Application>
  <PresentationFormat>On-screen Show (4:3)</PresentationFormat>
  <Paragraphs>8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University of Mississippi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S. Clemmer</dc:creator>
  <cp:lastModifiedBy>John Clemmer</cp:lastModifiedBy>
  <cp:revision>217</cp:revision>
  <cp:lastPrinted>2020-11-12T15:01:39Z</cp:lastPrinted>
  <dcterms:created xsi:type="dcterms:W3CDTF">2020-05-12T20:51:12Z</dcterms:created>
  <dcterms:modified xsi:type="dcterms:W3CDTF">2020-11-13T20:49:19Z</dcterms:modified>
</cp:coreProperties>
</file>